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62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9723" autoAdjust="0"/>
    <p:restoredTop sz="94660"/>
  </p:normalViewPr>
  <p:slideViewPr>
    <p:cSldViewPr>
      <p:cViewPr>
        <p:scale>
          <a:sx n="125" d="100"/>
          <a:sy n="125" d="100"/>
        </p:scale>
        <p:origin x="1733" y="-1512"/>
      </p:cViewPr>
      <p:guideLst>
        <p:guide orient="horz" pos="4662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04A4-4C5C-4974-B37A-65E596981372}" type="datetimeFigureOut">
              <a:rPr lang="zh-TW" altLang="en-US" smtClean="0"/>
              <a:t>2018/5/3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FEECF-2A2C-4F6B-85E6-859DAB26E6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331815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04A4-4C5C-4974-B37A-65E596981372}" type="datetimeFigureOut">
              <a:rPr lang="zh-TW" altLang="en-US" smtClean="0"/>
              <a:t>2018/5/3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FEECF-2A2C-4F6B-85E6-859DAB26E6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974996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04A4-4C5C-4974-B37A-65E596981372}" type="datetimeFigureOut">
              <a:rPr lang="zh-TW" altLang="en-US" smtClean="0"/>
              <a:t>2018/5/3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FEECF-2A2C-4F6B-85E6-859DAB26E6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04662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04A4-4C5C-4974-B37A-65E596981372}" type="datetimeFigureOut">
              <a:rPr lang="zh-TW" altLang="en-US" smtClean="0"/>
              <a:t>2018/5/3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FEECF-2A2C-4F6B-85E6-859DAB26E6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173099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04A4-4C5C-4974-B37A-65E596981372}" type="datetimeFigureOut">
              <a:rPr lang="zh-TW" altLang="en-US" smtClean="0"/>
              <a:t>2018/5/3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FEECF-2A2C-4F6B-85E6-859DAB26E6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17911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04A4-4C5C-4974-B37A-65E596981372}" type="datetimeFigureOut">
              <a:rPr lang="zh-TW" altLang="en-US" smtClean="0"/>
              <a:t>2018/5/30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FEECF-2A2C-4F6B-85E6-859DAB26E6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97523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04A4-4C5C-4974-B37A-65E596981372}" type="datetimeFigureOut">
              <a:rPr lang="zh-TW" altLang="en-US" smtClean="0"/>
              <a:t>2018/5/30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FEECF-2A2C-4F6B-85E6-859DAB26E6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50872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04A4-4C5C-4974-B37A-65E596981372}" type="datetimeFigureOut">
              <a:rPr lang="zh-TW" altLang="en-US" smtClean="0"/>
              <a:t>2018/5/30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FEECF-2A2C-4F6B-85E6-859DAB26E6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10356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04A4-4C5C-4974-B37A-65E596981372}" type="datetimeFigureOut">
              <a:rPr lang="zh-TW" altLang="en-US" smtClean="0"/>
              <a:t>2018/5/30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FEECF-2A2C-4F6B-85E6-859DAB26E6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407758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04A4-4C5C-4974-B37A-65E596981372}" type="datetimeFigureOut">
              <a:rPr lang="zh-TW" altLang="en-US" smtClean="0"/>
              <a:t>2018/5/30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FEECF-2A2C-4F6B-85E6-859DAB26E6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235998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7304A4-4C5C-4974-B37A-65E596981372}" type="datetimeFigureOut">
              <a:rPr lang="zh-TW" altLang="en-US" smtClean="0"/>
              <a:t>2018/5/30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FEECF-2A2C-4F6B-85E6-859DAB26E6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28569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7304A4-4C5C-4974-B37A-65E596981372}" type="datetimeFigureOut">
              <a:rPr lang="zh-TW" altLang="en-US" smtClean="0"/>
              <a:t>2018/5/30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6FEECF-2A2C-4F6B-85E6-859DAB26E62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675633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33418" y="1496616"/>
            <a:ext cx="6399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Fig.2F</a:t>
            </a: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292" y="1841780"/>
            <a:ext cx="333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文字方塊 4"/>
          <p:cNvSpPr txBox="1"/>
          <p:nvPr/>
        </p:nvSpPr>
        <p:spPr>
          <a:xfrm>
            <a:off x="33418" y="128464"/>
            <a:ext cx="655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Fig.2C</a:t>
            </a:r>
          </a:p>
        </p:txBody>
      </p:sp>
      <p:sp>
        <p:nvSpPr>
          <p:cNvPr id="8" name="文字方塊 7"/>
          <p:cNvSpPr txBox="1"/>
          <p:nvPr/>
        </p:nvSpPr>
        <p:spPr>
          <a:xfrm>
            <a:off x="1730102" y="128464"/>
            <a:ext cx="655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Fig.2D</a:t>
            </a:r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1916" y="545636"/>
            <a:ext cx="333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文字方塊 9"/>
          <p:cNvSpPr txBox="1"/>
          <p:nvPr/>
        </p:nvSpPr>
        <p:spPr>
          <a:xfrm>
            <a:off x="3407500" y="128464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Fig.2E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816" y="545636"/>
            <a:ext cx="171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74175" y="545636"/>
            <a:ext cx="171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1916" y="1841780"/>
            <a:ext cx="171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文字方塊 11"/>
          <p:cNvSpPr txBox="1"/>
          <p:nvPr/>
        </p:nvSpPr>
        <p:spPr>
          <a:xfrm>
            <a:off x="3407500" y="1496616"/>
            <a:ext cx="655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Fig.3B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632" y="3180128"/>
            <a:ext cx="333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文字方塊 13"/>
          <p:cNvSpPr txBox="1"/>
          <p:nvPr/>
        </p:nvSpPr>
        <p:spPr>
          <a:xfrm>
            <a:off x="33418" y="2853198"/>
            <a:ext cx="655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Fig.3C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文字方塊 14"/>
          <p:cNvSpPr txBox="1"/>
          <p:nvPr/>
        </p:nvSpPr>
        <p:spPr>
          <a:xfrm>
            <a:off x="3407500" y="4122719"/>
            <a:ext cx="6399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Fig.4F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6" name="Picture 2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1916" y="4476272"/>
            <a:ext cx="333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" name="Picture 3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632" y="4476272"/>
            <a:ext cx="333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" name="矩形 17"/>
          <p:cNvSpPr/>
          <p:nvPr/>
        </p:nvSpPr>
        <p:spPr>
          <a:xfrm>
            <a:off x="33418" y="4122719"/>
            <a:ext cx="64793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Fig.4E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矩形 18"/>
          <p:cNvSpPr/>
          <p:nvPr/>
        </p:nvSpPr>
        <p:spPr>
          <a:xfrm>
            <a:off x="3407500" y="2853198"/>
            <a:ext cx="6559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Fig.4C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5075056" y="2853198"/>
            <a:ext cx="65594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Fig.4D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1" name="Picture 2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11916" y="3180128"/>
            <a:ext cx="171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2" name="Picture 4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58377" y="3180128"/>
            <a:ext cx="171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3" name="文字方塊 22"/>
          <p:cNvSpPr txBox="1"/>
          <p:nvPr/>
        </p:nvSpPr>
        <p:spPr>
          <a:xfrm>
            <a:off x="33418" y="5410215"/>
            <a:ext cx="655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Fig.5B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5" name="Picture 2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09929" y="5772416"/>
            <a:ext cx="333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6" name="文字方塊 25"/>
          <p:cNvSpPr txBox="1"/>
          <p:nvPr/>
        </p:nvSpPr>
        <p:spPr>
          <a:xfrm>
            <a:off x="1730102" y="5410215"/>
            <a:ext cx="655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Fig.5C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7" name="Picture 2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883" y="7209119"/>
            <a:ext cx="333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8" name="文字方塊 27"/>
          <p:cNvSpPr txBox="1"/>
          <p:nvPr/>
        </p:nvSpPr>
        <p:spPr>
          <a:xfrm>
            <a:off x="33418" y="6826097"/>
            <a:ext cx="6399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b="1" dirty="0" smtClean="0">
                <a:latin typeface="Arial" pitchFamily="34" charset="0"/>
                <a:cs typeface="Arial" pitchFamily="34" charset="0"/>
              </a:rPr>
              <a:t>Fig.5F</a:t>
            </a:r>
            <a:endParaRPr lang="zh-TW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9" name="Picture 7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9982" y="8378768"/>
            <a:ext cx="333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4" name="Picture 5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417" y="5772416"/>
            <a:ext cx="171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2"/>
          <p:cNvPicPr>
            <a:picLocks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02903" y="8378768"/>
            <a:ext cx="333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3"/>
          <p:cNvPicPr>
            <a:picLocks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08292" y="7209119"/>
            <a:ext cx="3330000" cy="10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文字方塊 6"/>
          <p:cNvSpPr txBox="1"/>
          <p:nvPr/>
        </p:nvSpPr>
        <p:spPr>
          <a:xfrm>
            <a:off x="148367" y="408001"/>
            <a:ext cx="4347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 smtClean="0">
                <a:latin typeface="Arial" pitchFamily="34" charset="0"/>
                <a:cs typeface="Arial" pitchFamily="34" charset="0"/>
              </a:rPr>
              <a:t>ROS</a:t>
            </a:r>
            <a:endParaRPr lang="zh-TW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文字方塊 32"/>
          <p:cNvSpPr txBox="1"/>
          <p:nvPr/>
        </p:nvSpPr>
        <p:spPr>
          <a:xfrm>
            <a:off x="1758748" y="408001"/>
            <a:ext cx="4347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 smtClean="0">
                <a:latin typeface="Arial" pitchFamily="34" charset="0"/>
                <a:cs typeface="Arial" pitchFamily="34" charset="0"/>
              </a:rPr>
              <a:t>ROS</a:t>
            </a:r>
            <a:endParaRPr lang="zh-TW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文字方塊 33"/>
          <p:cNvSpPr txBox="1"/>
          <p:nvPr/>
        </p:nvSpPr>
        <p:spPr>
          <a:xfrm>
            <a:off x="3466505" y="408001"/>
            <a:ext cx="7296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 smtClean="0">
                <a:latin typeface="Arial" pitchFamily="34" charset="0"/>
                <a:cs typeface="Arial" pitchFamily="34" charset="0"/>
              </a:rPr>
              <a:t>apoptosis</a:t>
            </a:r>
            <a:endParaRPr lang="zh-TW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文字方塊 34"/>
          <p:cNvSpPr txBox="1"/>
          <p:nvPr/>
        </p:nvSpPr>
        <p:spPr>
          <a:xfrm>
            <a:off x="148367" y="1760604"/>
            <a:ext cx="7296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 smtClean="0">
                <a:latin typeface="Arial" pitchFamily="34" charset="0"/>
                <a:cs typeface="Arial" pitchFamily="34" charset="0"/>
              </a:rPr>
              <a:t>apoptosis</a:t>
            </a:r>
            <a:endParaRPr lang="zh-TW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文字方塊 35"/>
          <p:cNvSpPr txBox="1"/>
          <p:nvPr/>
        </p:nvSpPr>
        <p:spPr>
          <a:xfrm>
            <a:off x="148367" y="3108188"/>
            <a:ext cx="7296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 smtClean="0">
                <a:latin typeface="Arial" pitchFamily="34" charset="0"/>
                <a:cs typeface="Arial" pitchFamily="34" charset="0"/>
              </a:rPr>
              <a:t>apoptosis</a:t>
            </a:r>
            <a:endParaRPr lang="zh-TW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文字方塊 36"/>
          <p:cNvSpPr txBox="1"/>
          <p:nvPr/>
        </p:nvSpPr>
        <p:spPr>
          <a:xfrm>
            <a:off x="148367" y="4387740"/>
            <a:ext cx="7296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 smtClean="0">
                <a:latin typeface="Arial" pitchFamily="34" charset="0"/>
                <a:cs typeface="Arial" pitchFamily="34" charset="0"/>
              </a:rPr>
              <a:t>apoptosis</a:t>
            </a:r>
            <a:endParaRPr lang="zh-TW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文字方塊 37"/>
          <p:cNvSpPr txBox="1"/>
          <p:nvPr/>
        </p:nvSpPr>
        <p:spPr>
          <a:xfrm>
            <a:off x="3466505" y="4387740"/>
            <a:ext cx="7296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 smtClean="0">
                <a:latin typeface="Arial" pitchFamily="34" charset="0"/>
                <a:cs typeface="Arial" pitchFamily="34" charset="0"/>
              </a:rPr>
              <a:t>apoptosis</a:t>
            </a:r>
            <a:endParaRPr lang="zh-TW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文字方塊 38"/>
          <p:cNvSpPr txBox="1"/>
          <p:nvPr/>
        </p:nvSpPr>
        <p:spPr>
          <a:xfrm>
            <a:off x="1758748" y="5700476"/>
            <a:ext cx="72968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 smtClean="0">
                <a:latin typeface="Arial" pitchFamily="34" charset="0"/>
                <a:cs typeface="Arial" pitchFamily="34" charset="0"/>
              </a:rPr>
              <a:t>apoptosis</a:t>
            </a:r>
            <a:endParaRPr lang="zh-TW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文字方塊 39"/>
          <p:cNvSpPr txBox="1"/>
          <p:nvPr/>
        </p:nvSpPr>
        <p:spPr>
          <a:xfrm>
            <a:off x="148367" y="7100214"/>
            <a:ext cx="10823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 smtClean="0">
                <a:latin typeface="Arial" pitchFamily="34" charset="0"/>
                <a:cs typeface="Arial" pitchFamily="34" charset="0"/>
              </a:rPr>
              <a:t>apoptosis(A549)</a:t>
            </a:r>
            <a:endParaRPr lang="zh-TW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文字方塊 40"/>
          <p:cNvSpPr txBox="1"/>
          <p:nvPr/>
        </p:nvSpPr>
        <p:spPr>
          <a:xfrm>
            <a:off x="3466505" y="7100214"/>
            <a:ext cx="11272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>
                <a:latin typeface="Arial" pitchFamily="34" charset="0"/>
                <a:cs typeface="Arial" pitchFamily="34" charset="0"/>
              </a:rPr>
              <a:t>a</a:t>
            </a:r>
            <a:r>
              <a:rPr lang="en-US" altLang="zh-TW" sz="900" b="1" dirty="0" smtClean="0">
                <a:latin typeface="Arial" pitchFamily="34" charset="0"/>
                <a:cs typeface="Arial" pitchFamily="34" charset="0"/>
              </a:rPr>
              <a:t>poptosis(CL1-5)</a:t>
            </a:r>
            <a:endParaRPr lang="zh-TW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文字方塊 41"/>
          <p:cNvSpPr txBox="1"/>
          <p:nvPr/>
        </p:nvSpPr>
        <p:spPr>
          <a:xfrm>
            <a:off x="3466505" y="1760604"/>
            <a:ext cx="4347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 smtClean="0">
                <a:latin typeface="Arial" pitchFamily="34" charset="0"/>
                <a:cs typeface="Arial" pitchFamily="34" charset="0"/>
              </a:rPr>
              <a:t>ROS</a:t>
            </a:r>
            <a:endParaRPr lang="zh-TW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文字方塊 42"/>
          <p:cNvSpPr txBox="1"/>
          <p:nvPr/>
        </p:nvSpPr>
        <p:spPr>
          <a:xfrm>
            <a:off x="3466505" y="3108188"/>
            <a:ext cx="4347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 smtClean="0">
                <a:latin typeface="Arial" pitchFamily="34" charset="0"/>
                <a:cs typeface="Arial" pitchFamily="34" charset="0"/>
              </a:rPr>
              <a:t>ROS</a:t>
            </a:r>
            <a:endParaRPr lang="zh-TW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文字方塊 43"/>
          <p:cNvSpPr txBox="1"/>
          <p:nvPr/>
        </p:nvSpPr>
        <p:spPr>
          <a:xfrm>
            <a:off x="148367" y="5700476"/>
            <a:ext cx="4347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 smtClean="0">
                <a:latin typeface="Arial" pitchFamily="34" charset="0"/>
                <a:cs typeface="Arial" pitchFamily="34" charset="0"/>
              </a:rPr>
              <a:t>ROS</a:t>
            </a:r>
            <a:endParaRPr lang="zh-TW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文字方塊 44"/>
          <p:cNvSpPr txBox="1"/>
          <p:nvPr/>
        </p:nvSpPr>
        <p:spPr>
          <a:xfrm>
            <a:off x="148367" y="8291021"/>
            <a:ext cx="7873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 smtClean="0">
                <a:latin typeface="Arial" pitchFamily="34" charset="0"/>
                <a:cs typeface="Arial" pitchFamily="34" charset="0"/>
              </a:rPr>
              <a:t>ROS(A549)</a:t>
            </a:r>
            <a:endParaRPr lang="zh-TW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文字方塊 45"/>
          <p:cNvSpPr txBox="1"/>
          <p:nvPr/>
        </p:nvSpPr>
        <p:spPr>
          <a:xfrm>
            <a:off x="3466505" y="8292764"/>
            <a:ext cx="8322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 smtClean="0">
                <a:latin typeface="Arial" pitchFamily="34" charset="0"/>
                <a:cs typeface="Arial" pitchFamily="34" charset="0"/>
              </a:rPr>
              <a:t>ROS(CL1-5)</a:t>
            </a:r>
            <a:endParaRPr lang="zh-TW" altLang="en-US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文字方塊 46"/>
          <p:cNvSpPr txBox="1"/>
          <p:nvPr/>
        </p:nvSpPr>
        <p:spPr>
          <a:xfrm>
            <a:off x="5109568" y="3105176"/>
            <a:ext cx="4347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900" b="1" dirty="0" smtClean="0">
                <a:latin typeface="Arial" pitchFamily="34" charset="0"/>
                <a:cs typeface="Arial" pitchFamily="34" charset="0"/>
              </a:rPr>
              <a:t>ROS</a:t>
            </a:r>
            <a:endParaRPr lang="zh-TW" altLang="en-US" sz="9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65456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21</TotalTime>
  <Words>33</Words>
  <Application>Microsoft Office PowerPoint</Application>
  <PresentationFormat>A4 紙張 (210x297 公釐)</PresentationFormat>
  <Paragraphs>29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5" baseType="lpstr">
      <vt:lpstr>新細明體</vt:lpstr>
      <vt:lpstr>Arial</vt:lpstr>
      <vt:lpstr>Calibri</vt:lpstr>
      <vt:lpstr>Office 佈景主題</vt:lpstr>
      <vt:lpstr>PowerPoint 簡報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謝佳倫</dc:creator>
  <cp:lastModifiedBy>81-0406L</cp:lastModifiedBy>
  <cp:revision>40</cp:revision>
  <dcterms:created xsi:type="dcterms:W3CDTF">2018-03-06T05:22:03Z</dcterms:created>
  <dcterms:modified xsi:type="dcterms:W3CDTF">2018-05-30T02:36:58Z</dcterms:modified>
</cp:coreProperties>
</file>